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64" r:id="rId2"/>
    <p:sldId id="265" r:id="rId3"/>
    <p:sldId id="266" r:id="rId4"/>
    <p:sldId id="268" r:id="rId5"/>
    <p:sldId id="267" r:id="rId6"/>
    <p:sldId id="269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376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17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0AF6C2-B418-B843-961D-0A754A8A83EF}" type="datetimeFigureOut">
              <a:rPr lang="en-US" smtClean="0"/>
              <a:t>3/14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A9EF13-7CA4-F64C-95D2-21E9332BC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251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42F714-20A1-DB42-A968-FFBA102C1A9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092857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42F714-20A1-DB42-A968-FFBA102C1A9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43145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42F714-20A1-DB42-A968-FFBA102C1A95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25655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42F714-20A1-DB42-A968-FFBA102C1A95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411622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42F714-20A1-DB42-A968-FFBA102C1A95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480869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42F714-20A1-DB42-A968-FFBA102C1A95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153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E70146-6B7D-824B-A53F-F9492421357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2C0F610-A2B6-1646-9B57-02A95A93DB6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4C494E-ABA5-5342-9DB3-89128DB6F1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1A0A8-453B-564A-B956-0C59E670827D}" type="datetimeFigureOut">
              <a:rPr lang="en-US" smtClean="0"/>
              <a:t>3/14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F95C8E-595D-994E-AF33-971788613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F34490-C0C1-2642-BACC-DCAE0E7925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9FB8-BEA7-B840-9825-E4FA57ED26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8410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F6473F-D8E3-5644-BCF2-D34E587453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247B13B-789E-A647-B2AD-6947F8BF2F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99A39D-D845-3E4E-A2BD-403F8BD078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1A0A8-453B-564A-B956-0C59E670827D}" type="datetimeFigureOut">
              <a:rPr lang="en-US" smtClean="0"/>
              <a:t>3/14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619D9D-1409-DB40-903F-AFEB994BD7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A85C33-AE93-4046-9316-D6AF699895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9FB8-BEA7-B840-9825-E4FA57ED26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18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3BD3688-1C1B-154E-9138-A5873FF2774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4367E8-7990-2C4C-8927-6B5839DFEC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92D3A1-7DFB-CB49-8304-B251F9BB56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1A0A8-453B-564A-B956-0C59E670827D}" type="datetimeFigureOut">
              <a:rPr lang="en-US" smtClean="0"/>
              <a:t>3/14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630EF2-BED1-144B-963F-D4698ADEE7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ACB3CF-6854-0E41-AC8C-B8B1DFC5FB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9FB8-BEA7-B840-9825-E4FA57ED26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6416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836CB3-E5D8-F64E-AFB2-BB48AAB1D7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0FD1D5-7D16-8A43-9A98-64D97FF86A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4AB02D-FC70-C14E-A54A-0DB0F4D069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1A0A8-453B-564A-B956-0C59E670827D}" type="datetimeFigureOut">
              <a:rPr lang="en-US" smtClean="0"/>
              <a:t>3/14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094291-AFB2-D945-AB88-1DF78AC668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90B8B9-F038-E949-868A-751BF86050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9FB8-BEA7-B840-9825-E4FA57ED26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3863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3CD925-1042-2349-A53C-D9266E75BE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B67534-185F-864C-9C92-B48E4D48F4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FE4DD9-B96B-544A-9564-22A9C7D2B3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1A0A8-453B-564A-B956-0C59E670827D}" type="datetimeFigureOut">
              <a:rPr lang="en-US" smtClean="0"/>
              <a:t>3/14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E99CA6-B830-1D48-8556-0EC37A4D09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4B37DA-563C-0C4F-9767-2855F5C84C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9FB8-BEA7-B840-9825-E4FA57ED26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3720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549656-B1C2-6B49-963B-945A49D91B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2AB928-B781-8242-A042-C011B18233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CD2482A-359F-8548-A830-C10B9017CA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C8A81D-5449-7843-8763-DA3C97025B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1A0A8-453B-564A-B956-0C59E670827D}" type="datetimeFigureOut">
              <a:rPr lang="en-US" smtClean="0"/>
              <a:t>3/14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7BA3B7-624A-364D-96FB-8F0976000D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2BE1E3-1E23-1945-92C5-1221F2D09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9FB8-BEA7-B840-9825-E4FA57ED26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7199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F537AD-15D7-B149-9D98-61184D76FC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760A87-A6DD-2A4A-A0CB-D35EAAFF47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E1B04C-92B4-7843-B163-265DC4C35B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55D126F-929C-F14D-A3D6-64E99FF3578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86ECE40-EC60-F94B-8433-AA1C15FCE2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31DAFFB-1F25-524E-B744-69267FA7FA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1A0A8-453B-564A-B956-0C59E670827D}" type="datetimeFigureOut">
              <a:rPr lang="en-US" smtClean="0"/>
              <a:t>3/14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D481A38-656C-7349-AE84-37F467F2A3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0254C2E-E3B5-B24F-A681-66A8EE73D2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9FB8-BEA7-B840-9825-E4FA57ED26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3567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92E9C8-8CC6-9A44-BA9E-21B87B2343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4AF3E3F-4D69-F44B-A0CA-8CDA9D92E9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1A0A8-453B-564A-B956-0C59E670827D}" type="datetimeFigureOut">
              <a:rPr lang="en-US" smtClean="0"/>
              <a:t>3/14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1A56DEC-1475-554A-BB19-E6FB6B9081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ED24995-E9C8-4542-B3C5-58B1192959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9FB8-BEA7-B840-9825-E4FA57ED26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299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2F0588E-024E-ED45-BD23-82AB655E19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1A0A8-453B-564A-B956-0C59E670827D}" type="datetimeFigureOut">
              <a:rPr lang="en-US" smtClean="0"/>
              <a:t>3/14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ECE0D32-F04B-C241-B586-3CE612DA41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8F9717B-E647-DE4E-80AF-F32053E249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9FB8-BEA7-B840-9825-E4FA57ED26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5695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C83DDF-5EB8-FE42-A8C7-3024535C37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C37151-3A60-CB42-9BED-162929993E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5E87E48-264C-2D46-84BD-B212F09957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8824DF-F51E-6C4F-8DE0-6F637422FE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1A0A8-453B-564A-B956-0C59E670827D}" type="datetimeFigureOut">
              <a:rPr lang="en-US" smtClean="0"/>
              <a:t>3/14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918686-77BA-BE48-83AB-D66EFD3147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0C4AA6-4AD8-5D49-9F5D-15F0D93ACB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9FB8-BEA7-B840-9825-E4FA57ED26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6089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007E2D-ED63-F54D-9FDA-BE9CB764F1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05F6289-0892-C44D-BC59-DD1EA6B52C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3E4070-413C-E24E-B0E6-BC32B9CC60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B74CF8-D656-1047-97A1-D859E69687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1A0A8-453B-564A-B956-0C59E670827D}" type="datetimeFigureOut">
              <a:rPr lang="en-US" smtClean="0"/>
              <a:t>3/14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9AA229-2606-7B4C-A51D-03BB591BCC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006B83-8699-3641-95C6-E7AD9D5AA7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9FB8-BEA7-B840-9825-E4FA57ED26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2221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231EA0D-B683-6C4D-AE40-3E57B77708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D1D718-7931-674E-AC4E-EEC523B1CB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3B6DD1-2FD3-BD49-A13C-91A29CD82AB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B1A0A8-453B-564A-B956-0C59E670827D}" type="datetimeFigureOut">
              <a:rPr lang="en-US" smtClean="0"/>
              <a:t>3/14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BE4404-E49A-D64C-9838-E07C6E4F507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0422C2-BCA9-1B43-BE08-13024014931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FC9FB8-BEA7-B840-9825-E4FA57ED26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44904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7F397CF-89A5-804F-932B-6D27985B38E5}"/>
              </a:ext>
            </a:extLst>
          </p:cNvPr>
          <p:cNvSpPr txBox="1"/>
          <p:nvPr/>
        </p:nvSpPr>
        <p:spPr>
          <a:xfrm>
            <a:off x="447261" y="357808"/>
            <a:ext cx="41248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8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r>
              <a:rPr lang="en-AU" sz="28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8" name="Picture 57" descr="Chart, diagram&#10;&#10;Description automatically generated">
            <a:extLst>
              <a:ext uri="{FF2B5EF4-FFF2-40B4-BE49-F238E27FC236}">
                <a16:creationId xmlns:a16="http://schemas.microsoft.com/office/drawing/2014/main" id="{9E139948-2A8C-AD43-A325-2F8EBFCAC2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30626" y="1719470"/>
            <a:ext cx="8552751" cy="36157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35097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7F397CF-89A5-804F-932B-6D27985B38E5}"/>
              </a:ext>
            </a:extLst>
          </p:cNvPr>
          <p:cNvSpPr txBox="1"/>
          <p:nvPr/>
        </p:nvSpPr>
        <p:spPr>
          <a:xfrm>
            <a:off x="447261" y="357808"/>
            <a:ext cx="41248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8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r>
              <a:rPr lang="en-AU" sz="28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507912E2-A3C2-4B43-8DFA-6AD2486EFE00}"/>
              </a:ext>
            </a:extLst>
          </p:cNvPr>
          <p:cNvGrpSpPr/>
          <p:nvPr/>
        </p:nvGrpSpPr>
        <p:grpSpPr>
          <a:xfrm>
            <a:off x="1180474" y="1929451"/>
            <a:ext cx="6360339" cy="3537899"/>
            <a:chOff x="1180474" y="1929451"/>
            <a:chExt cx="6360339" cy="3537899"/>
          </a:xfrm>
        </p:grpSpPr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FF12ADCE-3653-9A47-A47F-E725479DB8D4}"/>
                </a:ext>
              </a:extLst>
            </p:cNvPr>
            <p:cNvCxnSpPr/>
            <p:nvPr/>
          </p:nvCxnSpPr>
          <p:spPr>
            <a:xfrm>
              <a:off x="2438587" y="2594775"/>
              <a:ext cx="771276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5B5651B0-DA5E-E64E-BC05-85BE043715CF}"/>
                </a:ext>
              </a:extLst>
            </p:cNvPr>
            <p:cNvSpPr txBox="1"/>
            <p:nvPr/>
          </p:nvSpPr>
          <p:spPr>
            <a:xfrm>
              <a:off x="2606488" y="2385000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*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B5BAED8-62F5-2744-8B30-D639C35425C1}"/>
                </a:ext>
              </a:extLst>
            </p:cNvPr>
            <p:cNvSpPr txBox="1"/>
            <p:nvPr/>
          </p:nvSpPr>
          <p:spPr>
            <a:xfrm>
              <a:off x="1991306" y="5128796"/>
              <a:ext cx="84510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digesta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3F2AFE6-EED6-1F42-B069-A1462E71F8DB}"/>
                </a:ext>
              </a:extLst>
            </p:cNvPr>
            <p:cNvSpPr txBox="1"/>
            <p:nvPr/>
          </p:nvSpPr>
          <p:spPr>
            <a:xfrm>
              <a:off x="3027663" y="5127436"/>
              <a:ext cx="90281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mucosa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D4BF7D83-3EF6-A542-89AB-F07A2498D3CA}"/>
                </a:ext>
              </a:extLst>
            </p:cNvPr>
            <p:cNvSpPr txBox="1"/>
            <p:nvPr/>
          </p:nvSpPr>
          <p:spPr>
            <a:xfrm rot="16200000">
              <a:off x="694906" y="3581124"/>
              <a:ext cx="136928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Simpson 1-D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0B8FD49C-73EB-F048-BC18-3C3626EB23EF}"/>
                </a:ext>
              </a:extLst>
            </p:cNvPr>
            <p:cNvSpPr txBox="1"/>
            <p:nvPr/>
          </p:nvSpPr>
          <p:spPr>
            <a:xfrm>
              <a:off x="1180474" y="1929451"/>
              <a:ext cx="4972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</a:p>
          </p:txBody>
        </p:sp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33E43827-B1A8-3246-B9D9-DC486E92BA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664" b="12937"/>
            <a:stretch/>
          </p:blipFill>
          <p:spPr>
            <a:xfrm>
              <a:off x="4613275" y="2329561"/>
              <a:ext cx="2927538" cy="2841680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B9A39995-A3DF-3848-A204-1FB3EE52719F}"/>
                </a:ext>
              </a:extLst>
            </p:cNvPr>
            <p:cNvSpPr txBox="1"/>
            <p:nvPr/>
          </p:nvSpPr>
          <p:spPr>
            <a:xfrm>
              <a:off x="5170695" y="5127436"/>
              <a:ext cx="84510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digesta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CED71AC-8A78-0F48-A6F5-4DFF7F8DD949}"/>
                </a:ext>
              </a:extLst>
            </p:cNvPr>
            <p:cNvSpPr txBox="1"/>
            <p:nvPr/>
          </p:nvSpPr>
          <p:spPr>
            <a:xfrm>
              <a:off x="6355312" y="5127436"/>
              <a:ext cx="90281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mucosa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BB0F4F68-DE71-0A4B-BCF5-4FA5DC36BA68}"/>
                </a:ext>
              </a:extLst>
            </p:cNvPr>
            <p:cNvSpPr txBox="1"/>
            <p:nvPr/>
          </p:nvSpPr>
          <p:spPr>
            <a:xfrm rot="16200000">
              <a:off x="3598679" y="3563592"/>
              <a:ext cx="183043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Pielou’s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evenness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04EC3E5-BD6E-FF41-92AB-04B2C7185B58}"/>
                </a:ext>
              </a:extLst>
            </p:cNvPr>
            <p:cNvSpPr txBox="1"/>
            <p:nvPr/>
          </p:nvSpPr>
          <p:spPr>
            <a:xfrm>
              <a:off x="4344620" y="1929451"/>
              <a:ext cx="4972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</a:p>
          </p:txBody>
        </p: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570FA494-AB7F-E242-A870-CAB02AAC0060}"/>
                </a:ext>
              </a:extLst>
            </p:cNvPr>
            <p:cNvCxnSpPr/>
            <p:nvPr/>
          </p:nvCxnSpPr>
          <p:spPr>
            <a:xfrm>
              <a:off x="5865691" y="2619884"/>
              <a:ext cx="771276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5BC0E7C2-AECF-0C49-A002-EBECB42B290A}"/>
                </a:ext>
              </a:extLst>
            </p:cNvPr>
            <p:cNvSpPr txBox="1"/>
            <p:nvPr/>
          </p:nvSpPr>
          <p:spPr>
            <a:xfrm>
              <a:off x="6101288" y="2402532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</a:t>
              </a:r>
            </a:p>
          </p:txBody>
        </p:sp>
      </p:grpSp>
      <p:pic>
        <p:nvPicPr>
          <p:cNvPr id="33" name="Picture 32" descr="Chart, box and whisker chart&#10;&#10;Description automatically generated">
            <a:extLst>
              <a:ext uri="{FF2B5EF4-FFF2-40B4-BE49-F238E27FC236}">
                <a16:creationId xmlns:a16="http://schemas.microsoft.com/office/drawing/2014/main" id="{F6686FC7-E4FE-BD42-ABC9-BB0FED281A0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693" b="12342"/>
          <a:stretch/>
        </p:blipFill>
        <p:spPr>
          <a:xfrm>
            <a:off x="1531174" y="2329561"/>
            <a:ext cx="2643689" cy="2841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74193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7F397CF-89A5-804F-932B-6D27985B38E5}"/>
              </a:ext>
            </a:extLst>
          </p:cNvPr>
          <p:cNvSpPr txBox="1"/>
          <p:nvPr/>
        </p:nvSpPr>
        <p:spPr>
          <a:xfrm>
            <a:off x="447261" y="357808"/>
            <a:ext cx="41248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8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r>
              <a:rPr lang="en-AU" sz="28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D0B1CE27-3EC9-284D-900B-59976A5EC9C8}"/>
              </a:ext>
            </a:extLst>
          </p:cNvPr>
          <p:cNvGrpSpPr/>
          <p:nvPr/>
        </p:nvGrpSpPr>
        <p:grpSpPr>
          <a:xfrm>
            <a:off x="889950" y="2061973"/>
            <a:ext cx="5918354" cy="3545335"/>
            <a:chOff x="889950" y="2061973"/>
            <a:chExt cx="5918354" cy="3545335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2BD87F4-4BF9-0B42-A054-F8A181A62502}"/>
                </a:ext>
              </a:extLst>
            </p:cNvPr>
            <p:cNvSpPr txBox="1"/>
            <p:nvPr/>
          </p:nvSpPr>
          <p:spPr>
            <a:xfrm>
              <a:off x="1650326" y="5267287"/>
              <a:ext cx="8002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606F91CB-C6E7-8642-AE9E-E77A0E768979}"/>
                </a:ext>
              </a:extLst>
            </p:cNvPr>
            <p:cNvSpPr txBox="1"/>
            <p:nvPr/>
          </p:nvSpPr>
          <p:spPr>
            <a:xfrm>
              <a:off x="2473085" y="5268754"/>
              <a:ext cx="131465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PMA treated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5D08FE2-8E40-CA4D-B6C1-3E98C7529FBE}"/>
                </a:ext>
              </a:extLst>
            </p:cNvPr>
            <p:cNvSpPr txBox="1"/>
            <p:nvPr/>
          </p:nvSpPr>
          <p:spPr>
            <a:xfrm rot="16200000">
              <a:off x="437907" y="3757469"/>
              <a:ext cx="136928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Simspon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1-D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BCECB20F-AE64-EB44-A1DC-5794B01685F7}"/>
                </a:ext>
              </a:extLst>
            </p:cNvPr>
            <p:cNvSpPr txBox="1"/>
            <p:nvPr/>
          </p:nvSpPr>
          <p:spPr>
            <a:xfrm>
              <a:off x="889950" y="2061973"/>
              <a:ext cx="4972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</a:p>
          </p:txBody>
        </p:sp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7CD61F62-D0D0-D94A-B2A7-FAA3DE5E4B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5012" b="11420"/>
            <a:stretch/>
          </p:blipFill>
          <p:spPr>
            <a:xfrm>
              <a:off x="4362449" y="2368315"/>
              <a:ext cx="2445855" cy="3003786"/>
            </a:xfrm>
            <a:prstGeom prst="rect">
              <a:avLst/>
            </a:prstGeom>
          </p:spPr>
        </p:pic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343BC6D5-C932-D34F-B62C-285002EB818A}"/>
                </a:ext>
              </a:extLst>
            </p:cNvPr>
            <p:cNvSpPr/>
            <p:nvPr/>
          </p:nvSpPr>
          <p:spPr>
            <a:xfrm>
              <a:off x="4474053" y="5314437"/>
              <a:ext cx="2066193" cy="12309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D3C1148-8C4E-214E-94D2-D43FF071F233}"/>
                </a:ext>
              </a:extLst>
            </p:cNvPr>
            <p:cNvSpPr txBox="1"/>
            <p:nvPr/>
          </p:nvSpPr>
          <p:spPr>
            <a:xfrm>
              <a:off x="4431283" y="5266078"/>
              <a:ext cx="8002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4E82FA1A-7688-274E-9EF5-616736A78772}"/>
                </a:ext>
              </a:extLst>
            </p:cNvPr>
            <p:cNvSpPr txBox="1"/>
            <p:nvPr/>
          </p:nvSpPr>
          <p:spPr>
            <a:xfrm>
              <a:off x="5188732" y="5266078"/>
              <a:ext cx="131465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PMA treated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5D989D31-4AF9-5144-BCCA-7ED3CA2A32C5}"/>
                </a:ext>
              </a:extLst>
            </p:cNvPr>
            <p:cNvSpPr txBox="1"/>
            <p:nvPr/>
          </p:nvSpPr>
          <p:spPr>
            <a:xfrm rot="16200000">
              <a:off x="3101518" y="3691539"/>
              <a:ext cx="183043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Pielou’s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evenness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8C87BB6B-B6B9-FA49-8ACB-05F821E8CE1C}"/>
                </a:ext>
              </a:extLst>
            </p:cNvPr>
            <p:cNvSpPr txBox="1"/>
            <p:nvPr/>
          </p:nvSpPr>
          <p:spPr>
            <a:xfrm>
              <a:off x="4113057" y="2368314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.7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D6B074AA-6020-454D-A515-1F9A98B3F6F8}"/>
                </a:ext>
              </a:extLst>
            </p:cNvPr>
            <p:cNvSpPr txBox="1"/>
            <p:nvPr/>
          </p:nvSpPr>
          <p:spPr>
            <a:xfrm>
              <a:off x="4100084" y="3283769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06C2ACD-5B49-F945-BDFE-2C62406A6417}"/>
                </a:ext>
              </a:extLst>
            </p:cNvPr>
            <p:cNvSpPr txBox="1"/>
            <p:nvPr/>
          </p:nvSpPr>
          <p:spPr>
            <a:xfrm>
              <a:off x="4100357" y="4197114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FD07C507-7414-EC4F-A50A-D79567A49909}"/>
                </a:ext>
              </a:extLst>
            </p:cNvPr>
            <p:cNvSpPr txBox="1"/>
            <p:nvPr/>
          </p:nvSpPr>
          <p:spPr>
            <a:xfrm>
              <a:off x="4113057" y="5107097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BD506AB7-9C6E-0542-8AA2-CCF1D32E0A95}"/>
                </a:ext>
              </a:extLst>
            </p:cNvPr>
            <p:cNvSpPr txBox="1"/>
            <p:nvPr/>
          </p:nvSpPr>
          <p:spPr>
            <a:xfrm>
              <a:off x="3756868" y="2061973"/>
              <a:ext cx="49725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</a:p>
          </p:txBody>
        </p:sp>
      </p:grpSp>
      <p:pic>
        <p:nvPicPr>
          <p:cNvPr id="39" name="Picture 38" descr="Chart, box and whisker chart&#10;&#10;Description automatically generated">
            <a:extLst>
              <a:ext uri="{FF2B5EF4-FFF2-40B4-BE49-F238E27FC236}">
                <a16:creationId xmlns:a16="http://schemas.microsoft.com/office/drawing/2014/main" id="{C7938547-8916-E146-902E-6B60C472D0A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6438" b="12196"/>
          <a:stretch/>
        </p:blipFill>
        <p:spPr>
          <a:xfrm>
            <a:off x="1456035" y="2352828"/>
            <a:ext cx="2354283" cy="2963534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928ED7A8-1838-9748-BAA9-2FFDDFEDCF8D}"/>
              </a:ext>
            </a:extLst>
          </p:cNvPr>
          <p:cNvSpPr txBox="1"/>
          <p:nvPr/>
        </p:nvSpPr>
        <p:spPr>
          <a:xfrm>
            <a:off x="1179852" y="5068216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A3FC3CF-7E06-EB49-AE3A-9BF9C47FDD67}"/>
              </a:ext>
            </a:extLst>
          </p:cNvPr>
          <p:cNvSpPr txBox="1"/>
          <p:nvPr/>
        </p:nvSpPr>
        <p:spPr>
          <a:xfrm>
            <a:off x="1196002" y="4285166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7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65F826F-6805-8949-89F3-C628E11B7C0A}"/>
              </a:ext>
            </a:extLst>
          </p:cNvPr>
          <p:cNvSpPr txBox="1"/>
          <p:nvPr/>
        </p:nvSpPr>
        <p:spPr>
          <a:xfrm>
            <a:off x="1179852" y="3519917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A873A4E-5340-6B46-A2E1-78DCD3915E40}"/>
              </a:ext>
            </a:extLst>
          </p:cNvPr>
          <p:cNvSpPr txBox="1"/>
          <p:nvPr/>
        </p:nvSpPr>
        <p:spPr>
          <a:xfrm>
            <a:off x="1179852" y="2755796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9</a:t>
            </a:r>
          </a:p>
        </p:txBody>
      </p:sp>
    </p:spTree>
    <p:extLst>
      <p:ext uri="{BB962C8B-B14F-4D97-AF65-F5344CB8AC3E}">
        <p14:creationId xmlns:p14="http://schemas.microsoft.com/office/powerpoint/2010/main" val="17246182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7F397CF-89A5-804F-932B-6D27985B38E5}"/>
              </a:ext>
            </a:extLst>
          </p:cNvPr>
          <p:cNvSpPr txBox="1"/>
          <p:nvPr/>
        </p:nvSpPr>
        <p:spPr>
          <a:xfrm>
            <a:off x="447261" y="357808"/>
            <a:ext cx="41248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8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r>
              <a:rPr lang="en-AU" sz="28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0245AE69-52CB-CE40-99E4-D5A11C909C09}"/>
              </a:ext>
            </a:extLst>
          </p:cNvPr>
          <p:cNvGrpSpPr/>
          <p:nvPr/>
        </p:nvGrpSpPr>
        <p:grpSpPr>
          <a:xfrm>
            <a:off x="3107513" y="1789043"/>
            <a:ext cx="3850374" cy="4213599"/>
            <a:chOff x="7645255" y="1016639"/>
            <a:chExt cx="2754952" cy="3495420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8AF3C266-7774-B841-8C5B-1D68553110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2450" b="13958"/>
            <a:stretch/>
          </p:blipFill>
          <p:spPr>
            <a:xfrm>
              <a:off x="8410951" y="1016639"/>
              <a:ext cx="1989256" cy="3238501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5F3D8C0-8A73-5B4E-B5F7-81E9B9A762DB}"/>
                </a:ext>
              </a:extLst>
            </p:cNvPr>
            <p:cNvSpPr txBox="1"/>
            <p:nvPr/>
          </p:nvSpPr>
          <p:spPr>
            <a:xfrm>
              <a:off x="8140493" y="1288614"/>
              <a:ext cx="315641" cy="3063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AFB7F8B-2ADC-4443-82E6-154727E81ECD}"/>
                </a:ext>
              </a:extLst>
            </p:cNvPr>
            <p:cNvSpPr txBox="1"/>
            <p:nvPr/>
          </p:nvSpPr>
          <p:spPr>
            <a:xfrm>
              <a:off x="8140493" y="1937566"/>
              <a:ext cx="315641" cy="3063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F35C7A7-E316-E74A-BAFE-7369DD512720}"/>
                </a:ext>
              </a:extLst>
            </p:cNvPr>
            <p:cNvSpPr txBox="1"/>
            <p:nvPr/>
          </p:nvSpPr>
          <p:spPr>
            <a:xfrm>
              <a:off x="8140493" y="2586118"/>
              <a:ext cx="315641" cy="3063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E450C25-74D2-494D-91FE-A7F39A109454}"/>
                </a:ext>
              </a:extLst>
            </p:cNvPr>
            <p:cNvSpPr txBox="1"/>
            <p:nvPr/>
          </p:nvSpPr>
          <p:spPr>
            <a:xfrm>
              <a:off x="8140493" y="3247533"/>
              <a:ext cx="315641" cy="3063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4E1DBCB-70BA-CA42-87B8-7A6FC71A2D05}"/>
                </a:ext>
              </a:extLst>
            </p:cNvPr>
            <p:cNvSpPr txBox="1"/>
            <p:nvPr/>
          </p:nvSpPr>
          <p:spPr>
            <a:xfrm>
              <a:off x="8254308" y="3889586"/>
              <a:ext cx="223885" cy="3063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5E8C3ED-4E54-9847-89BB-FF9384393799}"/>
                </a:ext>
              </a:extLst>
            </p:cNvPr>
            <p:cNvSpPr txBox="1"/>
            <p:nvPr/>
          </p:nvSpPr>
          <p:spPr>
            <a:xfrm rot="16200000">
              <a:off x="6278077" y="2415002"/>
              <a:ext cx="3196807" cy="4624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Relative abundance of </a:t>
              </a:r>
              <a:r>
                <a:rPr lang="en-US" dirty="0" err="1">
                  <a:latin typeface="Arial" panose="020B0604020202020204" pitchFamily="34" charset="0"/>
                  <a:cs typeface="Arial" panose="020B0604020202020204" pitchFamily="34" charset="0"/>
                </a:rPr>
                <a:t>Lactobacillales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 related ASVs (%)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CF8D7D4-3762-B240-AEF0-AA1489363CCC}"/>
                </a:ext>
              </a:extLst>
            </p:cNvPr>
            <p:cNvSpPr txBox="1"/>
            <p:nvPr/>
          </p:nvSpPr>
          <p:spPr>
            <a:xfrm>
              <a:off x="8621353" y="4195378"/>
              <a:ext cx="627612" cy="3063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373EE184-EA3F-954C-930E-D6D168E72060}"/>
                </a:ext>
              </a:extLst>
            </p:cNvPr>
            <p:cNvSpPr txBox="1"/>
            <p:nvPr/>
          </p:nvSpPr>
          <p:spPr>
            <a:xfrm>
              <a:off x="9300709" y="4205677"/>
              <a:ext cx="1040562" cy="3063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PMA treated</a:t>
              </a:r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E8AB1B39-886A-9A4F-89AF-E3C2194DE233}"/>
                </a:ext>
              </a:extLst>
            </p:cNvPr>
            <p:cNvCxnSpPr>
              <a:cxnSpLocks/>
            </p:cNvCxnSpPr>
            <p:nvPr/>
          </p:nvCxnSpPr>
          <p:spPr>
            <a:xfrm>
              <a:off x="9122603" y="1334714"/>
              <a:ext cx="50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739B806-AE72-DA4F-84CC-5D1A3828EA0A}"/>
                </a:ext>
              </a:extLst>
            </p:cNvPr>
            <p:cNvSpPr txBox="1"/>
            <p:nvPr/>
          </p:nvSpPr>
          <p:spPr>
            <a:xfrm>
              <a:off x="9240773" y="1113639"/>
              <a:ext cx="297290" cy="3063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737865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7F397CF-89A5-804F-932B-6D27985B38E5}"/>
              </a:ext>
            </a:extLst>
          </p:cNvPr>
          <p:cNvSpPr txBox="1"/>
          <p:nvPr/>
        </p:nvSpPr>
        <p:spPr>
          <a:xfrm>
            <a:off x="447261" y="357808"/>
            <a:ext cx="41248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8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  <a:r>
              <a:rPr lang="en-AU" sz="28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516BE84D-1586-F74A-8B44-9B4F0F00FC89}"/>
              </a:ext>
            </a:extLst>
          </p:cNvPr>
          <p:cNvGrpSpPr/>
          <p:nvPr/>
        </p:nvGrpSpPr>
        <p:grpSpPr>
          <a:xfrm>
            <a:off x="965958" y="1756642"/>
            <a:ext cx="7809389" cy="4015957"/>
            <a:chOff x="965958" y="1756642"/>
            <a:chExt cx="7809389" cy="4015957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3825E102-92DA-8243-87E0-26E551EA60A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12869"/>
            <a:stretch/>
          </p:blipFill>
          <p:spPr>
            <a:xfrm>
              <a:off x="5087582" y="2088109"/>
              <a:ext cx="3687765" cy="3343702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097B4B92-3526-5141-BAB6-2600AAE32D2D}"/>
                </a:ext>
              </a:extLst>
            </p:cNvPr>
            <p:cNvSpPr txBox="1"/>
            <p:nvPr/>
          </p:nvSpPr>
          <p:spPr>
            <a:xfrm>
              <a:off x="1959973" y="5403267"/>
              <a:ext cx="8771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7B38C3B4-9782-3441-A685-8DCC354EEE02}"/>
                </a:ext>
              </a:extLst>
            </p:cNvPr>
            <p:cNvSpPr txBox="1"/>
            <p:nvPr/>
          </p:nvSpPr>
          <p:spPr>
            <a:xfrm>
              <a:off x="3061197" y="5402424"/>
              <a:ext cx="145430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PMA treated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823EF2B2-A608-F044-90EA-C98B4D62D500}"/>
                </a:ext>
              </a:extLst>
            </p:cNvPr>
            <p:cNvSpPr txBox="1"/>
            <p:nvPr/>
          </p:nvSpPr>
          <p:spPr>
            <a:xfrm>
              <a:off x="6096000" y="5402424"/>
              <a:ext cx="8771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5044ECDC-8BAA-6E41-8F19-D9D12217C4B1}"/>
                </a:ext>
              </a:extLst>
            </p:cNvPr>
            <p:cNvSpPr txBox="1"/>
            <p:nvPr/>
          </p:nvSpPr>
          <p:spPr>
            <a:xfrm>
              <a:off x="7197224" y="5401581"/>
              <a:ext cx="145430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PMA treated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EE7A347-0E35-3044-960F-EDBFE31D916E}"/>
                </a:ext>
              </a:extLst>
            </p:cNvPr>
            <p:cNvSpPr txBox="1"/>
            <p:nvPr/>
          </p:nvSpPr>
          <p:spPr>
            <a:xfrm>
              <a:off x="965958" y="1756642"/>
              <a:ext cx="4972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5F4C89D-75DF-2E41-B1B0-36641C4323F3}"/>
                </a:ext>
              </a:extLst>
            </p:cNvPr>
            <p:cNvSpPr txBox="1"/>
            <p:nvPr/>
          </p:nvSpPr>
          <p:spPr>
            <a:xfrm>
              <a:off x="5004468" y="1756642"/>
              <a:ext cx="49725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</a:p>
          </p:txBody>
        </p:sp>
      </p:grpSp>
      <p:pic>
        <p:nvPicPr>
          <p:cNvPr id="22" name="Picture 21" descr="Chart, box and whisker chart&#10;&#10;Description automatically generated">
            <a:extLst>
              <a:ext uri="{FF2B5EF4-FFF2-40B4-BE49-F238E27FC236}">
                <a16:creationId xmlns:a16="http://schemas.microsoft.com/office/drawing/2014/main" id="{6011B753-0BC4-9145-951B-B437569D3E2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000" b="11919"/>
          <a:stretch/>
        </p:blipFill>
        <p:spPr>
          <a:xfrm>
            <a:off x="1316303" y="2076830"/>
            <a:ext cx="3267070" cy="3340193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D31063C5-CFE2-B24F-912A-E282D9634FA6}"/>
              </a:ext>
            </a:extLst>
          </p:cNvPr>
          <p:cNvSpPr txBox="1"/>
          <p:nvPr/>
        </p:nvSpPr>
        <p:spPr>
          <a:xfrm rot="16200000">
            <a:off x="391442" y="3562260"/>
            <a:ext cx="1518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imspon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1-D</a:t>
            </a:r>
          </a:p>
        </p:txBody>
      </p:sp>
    </p:spTree>
    <p:extLst>
      <p:ext uri="{BB962C8B-B14F-4D97-AF65-F5344CB8AC3E}">
        <p14:creationId xmlns:p14="http://schemas.microsoft.com/office/powerpoint/2010/main" val="2719875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7F397CF-89A5-804F-932B-6D27985B38E5}"/>
              </a:ext>
            </a:extLst>
          </p:cNvPr>
          <p:cNvSpPr txBox="1"/>
          <p:nvPr/>
        </p:nvSpPr>
        <p:spPr>
          <a:xfrm>
            <a:off x="447261" y="357808"/>
            <a:ext cx="41248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8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  <a:r>
              <a:rPr lang="en-AU" sz="28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51012E2D-265C-0C4E-ABD5-BCF29AE00CC9}"/>
              </a:ext>
            </a:extLst>
          </p:cNvPr>
          <p:cNvGrpSpPr/>
          <p:nvPr/>
        </p:nvGrpSpPr>
        <p:grpSpPr>
          <a:xfrm>
            <a:off x="2799400" y="1224901"/>
            <a:ext cx="4015238" cy="4565871"/>
            <a:chOff x="2799400" y="1224901"/>
            <a:chExt cx="4015238" cy="4565871"/>
          </a:xfrm>
        </p:grpSpPr>
        <p:pic>
          <p:nvPicPr>
            <p:cNvPr id="4" name="Picture 3" descr="A screenshot of a cell phone&#10;&#10;Description automatically generated">
              <a:extLst>
                <a:ext uri="{FF2B5EF4-FFF2-40B4-BE49-F238E27FC236}">
                  <a16:creationId xmlns:a16="http://schemas.microsoft.com/office/drawing/2014/main" id="{A014304D-78BA-0144-A5FF-A2A87823A27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7096" b="17025"/>
            <a:stretch/>
          </p:blipFill>
          <p:spPr>
            <a:xfrm>
              <a:off x="4124739" y="1224901"/>
              <a:ext cx="2689899" cy="4244264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86A7F06-32CF-764B-B3EB-08B40B96F7D3}"/>
                </a:ext>
              </a:extLst>
            </p:cNvPr>
            <p:cNvSpPr txBox="1"/>
            <p:nvPr/>
          </p:nvSpPr>
          <p:spPr>
            <a:xfrm rot="16200000">
              <a:off x="1195749" y="3023868"/>
              <a:ext cx="3853632" cy="646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Relative abundance of </a:t>
              </a:r>
              <a:r>
                <a:rPr lang="en-US" dirty="0" err="1">
                  <a:latin typeface="Arial" panose="020B0604020202020204" pitchFamily="34" charset="0"/>
                  <a:cs typeface="Arial" panose="020B0604020202020204" pitchFamily="34" charset="0"/>
                </a:rPr>
                <a:t>Lactobacillales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 related ASVs (%)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A56B277-61B7-214F-A447-18139ACD8AD5}"/>
                </a:ext>
              </a:extLst>
            </p:cNvPr>
            <p:cNvSpPr txBox="1"/>
            <p:nvPr/>
          </p:nvSpPr>
          <p:spPr>
            <a:xfrm>
              <a:off x="3889118" y="4964151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F8D8613-6799-4849-AC29-2D45A2FDB884}"/>
                </a:ext>
              </a:extLst>
            </p:cNvPr>
            <p:cNvSpPr txBox="1"/>
            <p:nvPr/>
          </p:nvSpPr>
          <p:spPr>
            <a:xfrm>
              <a:off x="3696757" y="4168643"/>
              <a:ext cx="5052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8E60BF4-25C6-4947-A927-A88C845AB30B}"/>
                </a:ext>
              </a:extLst>
            </p:cNvPr>
            <p:cNvSpPr txBox="1"/>
            <p:nvPr/>
          </p:nvSpPr>
          <p:spPr>
            <a:xfrm>
              <a:off x="3696757" y="3401557"/>
              <a:ext cx="5052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5.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38CC703-14D0-F441-9605-9AA7916EAFE8}"/>
                </a:ext>
              </a:extLst>
            </p:cNvPr>
            <p:cNvSpPr txBox="1"/>
            <p:nvPr/>
          </p:nvSpPr>
          <p:spPr>
            <a:xfrm>
              <a:off x="3696757" y="2625897"/>
              <a:ext cx="5052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7.5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39677AA-9170-6E43-8701-1D5B92932F50}"/>
                </a:ext>
              </a:extLst>
            </p:cNvPr>
            <p:cNvSpPr txBox="1"/>
            <p:nvPr/>
          </p:nvSpPr>
          <p:spPr>
            <a:xfrm>
              <a:off x="3593995" y="1830389"/>
              <a:ext cx="6335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10.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47FA48E-2A80-4E43-8F99-9B861ADF8CC9}"/>
                </a:ext>
              </a:extLst>
            </p:cNvPr>
            <p:cNvSpPr txBox="1"/>
            <p:nvPr/>
          </p:nvSpPr>
          <p:spPr>
            <a:xfrm>
              <a:off x="4410847" y="5409025"/>
              <a:ext cx="8771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53791AE-ABDE-8E47-87C9-D1BD2375332C}"/>
                </a:ext>
              </a:extLst>
            </p:cNvPr>
            <p:cNvSpPr txBox="1"/>
            <p:nvPr/>
          </p:nvSpPr>
          <p:spPr>
            <a:xfrm>
              <a:off x="5360328" y="5421440"/>
              <a:ext cx="14543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PMA treated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07D059F-4B84-C843-96C7-CE58A72B30E7}"/>
                </a:ext>
              </a:extLst>
            </p:cNvPr>
            <p:cNvSpPr txBox="1"/>
            <p:nvPr/>
          </p:nvSpPr>
          <p:spPr>
            <a:xfrm>
              <a:off x="5288010" y="1645723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*</a:t>
              </a:r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5CE1147D-213C-8B4E-A0C5-C8603C85CAE8}"/>
                </a:ext>
              </a:extLst>
            </p:cNvPr>
            <p:cNvCxnSpPr/>
            <p:nvPr/>
          </p:nvCxnSpPr>
          <p:spPr>
            <a:xfrm>
              <a:off x="5099900" y="1880276"/>
              <a:ext cx="771276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7678149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73</TotalTime>
  <Words>110</Words>
  <Application>Microsoft Macintosh PowerPoint</Application>
  <PresentationFormat>Widescreen</PresentationFormat>
  <Paragraphs>63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ibault Philippe Raymond Albert Legrand</dc:creator>
  <cp:lastModifiedBy>Thibault Philippe Raymond Albert Legrand</cp:lastModifiedBy>
  <cp:revision>14</cp:revision>
  <dcterms:created xsi:type="dcterms:W3CDTF">2020-10-08T05:19:44Z</dcterms:created>
  <dcterms:modified xsi:type="dcterms:W3CDTF">2021-03-14T07:31:36Z</dcterms:modified>
</cp:coreProperties>
</file>